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71930-D7DC-4C82-9EE3-203373C9E1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75F14-948B-4470-9227-618614DEBE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4A4EF6-471D-448A-8126-37C30AED91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4D0E5-D009-4ABA-AEFF-3BD24CE19A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9AB4A-092D-444A-BD33-19A20F011B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8BB6D-D341-46B8-A34B-A5759B9D1E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62C9E-8EF1-424F-A3B0-F10CD02A49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C274B-4CA3-403E-840A-2CA2A3A888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6D4EA-9FDE-4A31-90C7-E7ECBF3E85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43AD5-CB6A-46B9-86EA-D1E5B1C68B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4F279-6C94-46AF-AB21-7FBDC40C06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AED79-C5D3-4340-B526-1B0658CC16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133EB7F-0F04-4734-AEA9-7CD0662F6040}" type="datetime">
              <a:rPr b="0" lang="pt-B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6AEDF50-9D1D-4FE0-A36D-C8B9FA32AC46}" type="slidenum">
              <a:rPr b="0" lang="pt-B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585720" y="6181560"/>
            <a:ext cx="79614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istribution of the most frequent Eu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k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ryotic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O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thologous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G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oups categories observed for the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Taenia solium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equences. After RPSBlast analysis using the KOG categories 133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T. solium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EST sequences had hit with one KOG at least (Additional File 9 - Table 9), among these the major part was Actin regulatory protei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5"/>
          <p:cNvSpPr/>
          <p:nvPr/>
        </p:nvSpPr>
        <p:spPr>
          <a:xfrm>
            <a:off x="3336840" y="87480"/>
            <a:ext cx="285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Calibri"/>
              </a:rPr>
              <a:t>Additional File 12 - Pict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6" descr="kog.jpg"/>
          <p:cNvPicPr/>
          <p:nvPr/>
        </p:nvPicPr>
        <p:blipFill>
          <a:blip r:embed="rId1"/>
          <a:stretch/>
        </p:blipFill>
        <p:spPr>
          <a:xfrm>
            <a:off x="735120" y="704880"/>
            <a:ext cx="7596000" cy="5316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22T20:12:58Z</dcterms:created>
  <dc:creator>Glauber Wagner</dc:creator>
  <dc:description/>
  <dc:language>en-US</dc:language>
  <cp:lastModifiedBy>Glauber Wagner</cp:lastModifiedBy>
  <cp:lastPrinted>2009-07-30T13:09:56Z</cp:lastPrinted>
  <dcterms:modified xsi:type="dcterms:W3CDTF">2009-07-30T13:10:03Z</dcterms:modified>
  <cp:revision>4</cp:revision>
  <dc:subject/>
  <dc:title>Slide 1</dc:title>
</cp:coreProperties>
</file>